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63"/>
  </p:normalViewPr>
  <p:slideViewPr>
    <p:cSldViewPr snapToGrid="0" snapToObjects="1" showGuides="1">
      <p:cViewPr>
        <p:scale>
          <a:sx n="152" d="100"/>
          <a:sy n="152" d="100"/>
        </p:scale>
        <p:origin x="1472" y="12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3B7DD-E575-F44B-91C5-CA9908A6A160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97353-4A63-D048-9E39-F35A5E5EA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17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3B7DD-E575-F44B-91C5-CA9908A6A160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97353-4A63-D048-9E39-F35A5E5EA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681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3B7DD-E575-F44B-91C5-CA9908A6A160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97353-4A63-D048-9E39-F35A5E5EA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9948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3B7DD-E575-F44B-91C5-CA9908A6A160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97353-4A63-D048-9E39-F35A5E5EA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6217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3B7DD-E575-F44B-91C5-CA9908A6A160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97353-4A63-D048-9E39-F35A5E5EA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4642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3B7DD-E575-F44B-91C5-CA9908A6A160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97353-4A63-D048-9E39-F35A5E5EA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081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3B7DD-E575-F44B-91C5-CA9908A6A160}" type="datetimeFigureOut">
              <a:rPr lang="en-US" smtClean="0"/>
              <a:t>5/27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97353-4A63-D048-9E39-F35A5E5EA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632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3B7DD-E575-F44B-91C5-CA9908A6A160}" type="datetimeFigureOut">
              <a:rPr lang="en-US" smtClean="0"/>
              <a:t>5/2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97353-4A63-D048-9E39-F35A5E5EA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8302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3B7DD-E575-F44B-91C5-CA9908A6A160}" type="datetimeFigureOut">
              <a:rPr lang="en-US" smtClean="0"/>
              <a:t>5/27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97353-4A63-D048-9E39-F35A5E5EA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836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3B7DD-E575-F44B-91C5-CA9908A6A160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97353-4A63-D048-9E39-F35A5E5EA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145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F3B7DD-E575-F44B-91C5-CA9908A6A160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197353-4A63-D048-9E39-F35A5E5EA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6220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F3B7DD-E575-F44B-91C5-CA9908A6A160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197353-4A63-D048-9E39-F35A5E5EAA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9292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2705E7B6-9DBE-EF47-BE88-F0B89A94D8D5}"/>
              </a:ext>
            </a:extLst>
          </p:cNvPr>
          <p:cNvSpPr/>
          <p:nvPr/>
        </p:nvSpPr>
        <p:spPr>
          <a:xfrm>
            <a:off x="1193706" y="5452213"/>
            <a:ext cx="5363881" cy="400110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synteni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CtCENs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CACD6E0-9F10-CF4E-9BF3-3C723D9EB7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5424009"/>
              </p:ext>
            </p:extLst>
          </p:nvPr>
        </p:nvGraphicFramePr>
        <p:xfrm>
          <a:off x="1226043" y="2797577"/>
          <a:ext cx="3945830" cy="2659350"/>
        </p:xfrm>
        <a:graphic>
          <a:graphicData uri="http://schemas.openxmlformats.org/drawingml/2006/table">
            <a:tbl>
              <a:tblPr firstRow="1" bandRow="1">
                <a:tableStyleId>{69012ECD-51FC-41F1-AA8D-1B2483CD663E}</a:tableStyleId>
              </a:tblPr>
              <a:tblGrid>
                <a:gridCol w="880365">
                  <a:extLst>
                    <a:ext uri="{9D8B030D-6E8A-4147-A177-3AD203B41FA5}">
                      <a16:colId xmlns:a16="http://schemas.microsoft.com/office/drawing/2014/main" val="1903920010"/>
                    </a:ext>
                  </a:extLst>
                </a:gridCol>
                <a:gridCol w="1080120">
                  <a:extLst>
                    <a:ext uri="{9D8B030D-6E8A-4147-A177-3AD203B41FA5}">
                      <a16:colId xmlns:a16="http://schemas.microsoft.com/office/drawing/2014/main" val="3366486907"/>
                    </a:ext>
                  </a:extLst>
                </a:gridCol>
                <a:gridCol w="1008112">
                  <a:extLst>
                    <a:ext uri="{9D8B030D-6E8A-4147-A177-3AD203B41FA5}">
                      <a16:colId xmlns:a16="http://schemas.microsoft.com/office/drawing/2014/main" val="3996069283"/>
                    </a:ext>
                  </a:extLst>
                </a:gridCol>
                <a:gridCol w="977233">
                  <a:extLst>
                    <a:ext uri="{9D8B030D-6E8A-4147-A177-3AD203B41FA5}">
                      <a16:colId xmlns:a16="http://schemas.microsoft.com/office/drawing/2014/main" val="520387563"/>
                    </a:ext>
                  </a:extLst>
                </a:gridCol>
              </a:tblGrid>
              <a:tr h="377185">
                <a:tc>
                  <a:txBody>
                    <a:bodyPr/>
                    <a:lstStyle/>
                    <a:p>
                      <a:pPr algn="ctr"/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*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 repeat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tral core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 repeat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bp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2590099"/>
                  </a:ext>
                </a:extLst>
              </a:tr>
              <a:tr h="377185">
                <a:tc>
                  <a:txBody>
                    <a:bodyPr/>
                    <a:lstStyle/>
                    <a:p>
                      <a:pPr algn="ctr"/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3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5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3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4087987"/>
                  </a:ext>
                </a:extLst>
              </a:tr>
              <a:tr h="377185">
                <a:tc>
                  <a:txBody>
                    <a:bodyPr/>
                    <a:lstStyle/>
                    <a:p>
                      <a:pPr algn="ctr"/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9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8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5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96878600"/>
                  </a:ext>
                </a:extLst>
              </a:tr>
              <a:tr h="377185">
                <a:tc>
                  <a:txBody>
                    <a:bodyPr/>
                    <a:lstStyle/>
                    <a:p>
                      <a:pPr algn="ctr"/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2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2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2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6409904"/>
                  </a:ext>
                </a:extLst>
              </a:tr>
              <a:tr h="377185">
                <a:tc>
                  <a:txBody>
                    <a:bodyPr/>
                    <a:lstStyle/>
                    <a:p>
                      <a:pPr algn="ctr"/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1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1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1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5973909"/>
                  </a:ext>
                </a:extLst>
              </a:tr>
              <a:tr h="377185">
                <a:tc>
                  <a:txBody>
                    <a:bodyPr/>
                    <a:lstStyle/>
                    <a:p>
                      <a:pPr algn="ctr"/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6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9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6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9204247"/>
                  </a:ext>
                </a:extLst>
              </a:tr>
              <a:tr h="377185">
                <a:tc>
                  <a:txBody>
                    <a:bodyPr/>
                    <a:lstStyle/>
                    <a:p>
                      <a:pPr algn="ctr"/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1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9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1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5578181"/>
                  </a:ext>
                </a:extLst>
              </a:tr>
            </a:tbl>
          </a:graphicData>
        </a:graphic>
      </p:graphicFrame>
      <p:sp>
        <p:nvSpPr>
          <p:cNvPr id="6" name="Rectangle 2">
            <a:extLst>
              <a:ext uri="{FF2B5EF4-FFF2-40B4-BE49-F238E27FC236}">
                <a16:creationId xmlns:a16="http://schemas.microsoft.com/office/drawing/2014/main" id="{78E97FD0-9663-6948-A96A-0DB84A784A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28895" y="2521626"/>
            <a:ext cx="662473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upplementary file 6: Features of centromere DNA elements in </a:t>
            </a:r>
            <a:r>
              <a:rPr kumimoji="0" lang="en-US" altLang="en-US" sz="1000" i="1" u="none" strike="noStrike" cap="none" normalizeH="0" baseline="0" dirty="0">
                <a:ln>
                  <a:noFill/>
                </a:ln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. </a:t>
            </a:r>
            <a:r>
              <a:rPr lang="en-US" altLang="en-US" sz="1000" i="1" dirty="0" err="1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viswanathii</a:t>
            </a:r>
            <a:endParaRPr kumimoji="0" lang="en-US" altLang="en-US" sz="1000" i="0" u="none" strike="noStrike" cap="none" normalizeH="0" baseline="0" dirty="0">
              <a:ln>
                <a:noFill/>
              </a:ln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608786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2" presetClass="entr" presetSubtype="8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10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/>
    </p:bld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8</Words>
  <Application>Microsoft Macintosh PowerPoint</Application>
  <PresentationFormat>A4 Paper (210x297 mm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hnendu guin</dc:creator>
  <cp:lastModifiedBy>krishnendu guin</cp:lastModifiedBy>
  <cp:revision>1</cp:revision>
  <dcterms:created xsi:type="dcterms:W3CDTF">2020-05-27T11:04:42Z</dcterms:created>
  <dcterms:modified xsi:type="dcterms:W3CDTF">2020-05-27T11:05:35Z</dcterms:modified>
</cp:coreProperties>
</file>